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4994" autoAdjust="0"/>
    <p:restoredTop sz="94660"/>
  </p:normalViewPr>
  <p:slideViewPr>
    <p:cSldViewPr snapToGrid="0">
      <p:cViewPr>
        <p:scale>
          <a:sx n="96" d="100"/>
          <a:sy n="96" d="100"/>
        </p:scale>
        <p:origin x="-336" y="-3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7D11D57C-C3B1-49A3-A5CF-3ACF2F2588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F5F4C706-D18A-47FF-BCE6-316DB64DD7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299089F1-B4B0-48DB-9672-670E98A89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DA520446-DA1C-4481-98C3-26204DDE8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CA281CBF-3F1E-4F95-BCC8-672CC636D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057582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F3F92D2D-80E3-484F-9E6C-27AE53EFAC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F7A66202-1675-43D6-812A-19BB563A0E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0B33D046-7D84-4406-AFF8-47EBFC9C5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7E55F11C-FEFA-4C18-9114-1BEA42DB4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52F5DA0C-7366-4024-B8ED-BF56715C4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871388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BD646B4F-9F46-4778-B302-D8A61836AE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C45F5767-D2CE-4162-BC94-5D800A1908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7AA669FB-40F7-410A-B58D-D4BD5CF38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5272E8BC-97FA-4508-9DF3-C443D7C00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723744D9-36C6-44DB-96CE-E2BC6A5EA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4286158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9563" y="273423"/>
            <a:ext cx="10971684" cy="1144631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609563" y="1604400"/>
            <a:ext cx="10971684" cy="397681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xmlns="" val="1443015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E02A0B4F-C78B-4D0D-80A1-B8564D2DA3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F667ABE5-AAC9-44FE-A2FE-F29BDE6C8C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D3E86C69-C8AF-4420-ABCF-EFAA86926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DFF38E3B-F620-4A29-A17B-119C77DD0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B78F08A1-AF5D-4707-BB44-4CB33BB39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782224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04BB83C-D7B3-4038-BFBA-2B43E888BD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07D02468-B085-4DEE-864E-AD451368E6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F0610CCC-83D5-4FD1-8CB3-F8A4D405A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3710C03F-CD66-40DE-AEAB-3ADFB59DF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193D5471-ED35-46C3-8DCA-3266AFFA3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886768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D36A2845-1216-4C7D-A446-D399B942AA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CFC5225D-9B97-4D14-BD46-BC26171102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A3C8B0EA-B0CB-4228-97F0-B84B055186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02D215AA-2EA0-43CA-B869-BE2F22279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3C7FBA77-CE5E-4018-93CB-19878DE31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BCD5DD86-1EA1-4CAD-9CA7-6E491B5B8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020894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BE0952A-91F9-4D84-8A1E-717077637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52362074-AC73-4266-B250-5506C92A6C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B640F92D-67EB-4D12-A139-CB0C3E8AA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DF23CE8C-AD2D-4E66-B61F-73A3245211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AC8BB634-00B7-43F6-AE7F-41087599E5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1EF0D366-59B6-477A-B00D-2EC6DA07B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BD3335DB-56BB-4E24-8E48-8B26CB67E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4D8E3319-A091-4408-99E1-706C35C83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784185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5065E417-98AF-48DB-83DF-E592D254A1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D9B822A2-D7AA-446F-9B87-4C4429A2B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D08BFF87-0143-4774-882A-A6E10085E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7C39FBE1-B015-43F8-A558-F8AC25943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044690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7345E819-2BF3-4E47-A8D9-4C270B0A4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7DF78689-4173-4AD3-82D0-E61365B40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DB95B94C-E859-4DF5-BD1F-1FE88EBDC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399365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530A867C-7936-47FD-861F-4DF6EEF89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D32A5521-59AC-4EDD-8958-412C936FE0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A3A17BC1-6F0A-44A2-BF1A-D911C301F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82C19B21-083B-42F5-A23A-AE5CAF459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BA915561-8749-45CC-BE84-84D4AF053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007C5EE9-0948-45B8-A4A0-561973E07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354991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051120F-1E88-4502-82A8-17A5D5C535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683A8AB2-C36C-4ACC-9AF0-77E4E6396E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65943399-29DA-4361-95C8-DF9F02334B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0CA79515-A1FB-4CF2-8134-3EFBB681B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BA8B5278-5259-4AF4-8B8A-1C83C126A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6DE07C7E-FCCC-4EBA-8EE1-1B47A5D19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67801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72D85EA0-DF10-4384-82F1-1A9FD44DE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C75BFF5B-71E1-4E3F-AD60-6796AF56F5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EDBEB2F1-5536-4895-94F3-A151BE374B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BDC9D-4E10-46FC-9ABE-82074480C8F3}" type="datetimeFigureOut">
              <a:rPr lang="es-ES" smtClean="0"/>
              <a:pPr/>
              <a:t>28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147DCEC4-12EC-4C7D-BC42-A5DE16EF27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95F48CCD-6BA9-4E19-B678-83EE8A2F61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505721-62CE-460D-9668-31C42713D56E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339685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xmlns="" id="{08264D06-AFF8-49F9-A9EF-A788EAAC6D9B}"/>
              </a:ext>
            </a:extLst>
          </p:cNvPr>
          <p:cNvSpPr txBox="1"/>
          <p:nvPr/>
        </p:nvSpPr>
        <p:spPr>
          <a:xfrm>
            <a:off x="205492" y="338887"/>
            <a:ext cx="11385477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lphaUcParenR"/>
            </a:pPr>
            <a:r>
              <a:rPr lang="es-ES" dirty="0"/>
              <a:t>                                                                                                        B)</a:t>
            </a:r>
          </a:p>
          <a:p>
            <a:pPr marL="342900" indent="-342900">
              <a:buAutoNum type="alphaUcParenR"/>
            </a:pPr>
            <a:endParaRPr lang="es-ES" dirty="0"/>
          </a:p>
          <a:p>
            <a:pPr marL="342900" indent="-342900">
              <a:buAutoNum type="alphaUcParenR"/>
            </a:pPr>
            <a:endParaRPr lang="es-ES" dirty="0"/>
          </a:p>
          <a:p>
            <a:pPr marL="342900" indent="-342900">
              <a:buAutoNum type="alphaUcParenR"/>
            </a:pPr>
            <a:endParaRPr lang="es-ES" dirty="0"/>
          </a:p>
          <a:p>
            <a:pPr marL="342900" indent="-342900">
              <a:buAutoNum type="alphaUcParenR"/>
            </a:pPr>
            <a:endParaRPr lang="es-ES" dirty="0"/>
          </a:p>
          <a:p>
            <a:endParaRPr lang="es-ES" dirty="0"/>
          </a:p>
          <a:p>
            <a:endParaRPr lang="es-ES" dirty="0"/>
          </a:p>
          <a:p>
            <a:endParaRPr lang="es-ES" dirty="0"/>
          </a:p>
          <a:p>
            <a:endParaRPr lang="es-ES" dirty="0"/>
          </a:p>
          <a:p>
            <a:endParaRPr lang="es-ES" dirty="0"/>
          </a:p>
          <a:p>
            <a:endParaRPr lang="es-ES" dirty="0"/>
          </a:p>
          <a:p>
            <a:endParaRPr lang="es-ES" dirty="0"/>
          </a:p>
          <a:p>
            <a:endParaRPr lang="es-ES" dirty="0"/>
          </a:p>
          <a:p>
            <a:endParaRPr lang="es-ES" dirty="0"/>
          </a:p>
          <a:p>
            <a:r>
              <a:rPr lang="es-ES" dirty="0"/>
              <a:t> C)                                                                                                                 D) </a:t>
            </a:r>
            <a:r>
              <a:rPr lang="es-ES" dirty="0" err="1"/>
              <a:t>Rooted</a:t>
            </a:r>
            <a:r>
              <a:rPr lang="es-ES" dirty="0"/>
              <a:t> </a:t>
            </a:r>
            <a:r>
              <a:rPr lang="es-ES" dirty="0" err="1"/>
              <a:t>species</a:t>
            </a:r>
            <a:r>
              <a:rPr lang="es-ES" dirty="0"/>
              <a:t> </a:t>
            </a:r>
            <a:r>
              <a:rPr lang="es-ES" dirty="0" err="1"/>
              <a:t>tree</a:t>
            </a:r>
            <a:endParaRPr lang="es-ES" dirty="0"/>
          </a:p>
          <a:p>
            <a:r>
              <a:rPr lang="es-ES" dirty="0"/>
              <a:t>           </a:t>
            </a:r>
          </a:p>
          <a:p>
            <a:r>
              <a:rPr lang="es-ES" dirty="0"/>
              <a:t>                                                                       </a:t>
            </a:r>
          </a:p>
        </p:txBody>
      </p:sp>
      <p:pic>
        <p:nvPicPr>
          <p:cNvPr id="70" name="69 Imagen"/>
          <p:cNvPicPr/>
          <p:nvPr/>
        </p:nvPicPr>
        <p:blipFill>
          <a:blip r:embed="rId2" cstate="print"/>
          <a:stretch/>
        </p:blipFill>
        <p:spPr>
          <a:xfrm>
            <a:off x="701215" y="528513"/>
            <a:ext cx="4524631" cy="3722683"/>
          </a:xfrm>
          <a:prstGeom prst="rect">
            <a:avLst/>
          </a:prstGeom>
          <a:ln>
            <a:noFill/>
          </a:ln>
        </p:spPr>
      </p:pic>
      <p:sp>
        <p:nvSpPr>
          <p:cNvPr id="71" name="TextShape 1"/>
          <p:cNvSpPr txBox="1"/>
          <p:nvPr/>
        </p:nvSpPr>
        <p:spPr>
          <a:xfrm>
            <a:off x="601030" y="1008871"/>
            <a:ext cx="3592063" cy="314142"/>
          </a:xfrm>
          <a:prstGeom prst="rect">
            <a:avLst/>
          </a:prstGeom>
          <a:noFill/>
          <a:ln>
            <a:noFill/>
          </a:ln>
        </p:spPr>
        <p:txBody>
          <a:bodyPr lIns="81638" tIns="40819" rIns="81638" bIns="40819"/>
          <a:lstStyle/>
          <a:p>
            <a:endParaRPr sz="1633" dirty="0"/>
          </a:p>
        </p:txBody>
      </p:sp>
      <p:pic>
        <p:nvPicPr>
          <p:cNvPr id="72" name="71 Imagen"/>
          <p:cNvPicPr/>
          <p:nvPr/>
        </p:nvPicPr>
        <p:blipFill>
          <a:blip r:embed="rId3" cstate="print"/>
          <a:stretch/>
        </p:blipFill>
        <p:spPr>
          <a:xfrm>
            <a:off x="7121652" y="591483"/>
            <a:ext cx="3158939" cy="3217489"/>
          </a:xfrm>
          <a:prstGeom prst="rect">
            <a:avLst/>
          </a:prstGeom>
          <a:ln>
            <a:noFill/>
          </a:ln>
        </p:spPr>
      </p:pic>
      <p:pic>
        <p:nvPicPr>
          <p:cNvPr id="73" name="72 Imagen"/>
          <p:cNvPicPr/>
          <p:nvPr/>
        </p:nvPicPr>
        <p:blipFill>
          <a:blip r:embed="rId4" cstate="print"/>
          <a:stretch/>
        </p:blipFill>
        <p:spPr>
          <a:xfrm>
            <a:off x="601030" y="4615802"/>
            <a:ext cx="5432301" cy="1004757"/>
          </a:xfrm>
          <a:prstGeom prst="rect">
            <a:avLst/>
          </a:prstGeom>
          <a:ln>
            <a:noFill/>
          </a:ln>
        </p:spPr>
      </p:pic>
      <p:grpSp>
        <p:nvGrpSpPr>
          <p:cNvPr id="18" name="17 Grupo"/>
          <p:cNvGrpSpPr/>
          <p:nvPr/>
        </p:nvGrpSpPr>
        <p:grpSpPr>
          <a:xfrm>
            <a:off x="7695838" y="4041786"/>
            <a:ext cx="3293503" cy="1709756"/>
            <a:chOff x="3640673" y="1586820"/>
            <a:chExt cx="3293503" cy="1709756"/>
          </a:xfrm>
        </p:grpSpPr>
        <p:grpSp>
          <p:nvGrpSpPr>
            <p:cNvPr id="19" name="12 Grupo"/>
            <p:cNvGrpSpPr/>
            <p:nvPr/>
          </p:nvGrpSpPr>
          <p:grpSpPr>
            <a:xfrm>
              <a:off x="3640673" y="1586820"/>
              <a:ext cx="3293503" cy="1610921"/>
              <a:chOff x="3640673" y="1586820"/>
              <a:chExt cx="3293503" cy="1610921"/>
            </a:xfrm>
          </p:grpSpPr>
          <p:pic>
            <p:nvPicPr>
              <p:cNvPr id="22" name="Picture 2" descr="C:\Users\USUARIO\AppData\Local\Temp\rootedTree_Dre.pn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640673" y="1647427"/>
                <a:ext cx="2870215" cy="1550314"/>
              </a:xfrm>
              <a:prstGeom prst="rect">
                <a:avLst/>
              </a:prstGeom>
              <a:noFill/>
            </p:spPr>
          </p:pic>
          <p:sp>
            <p:nvSpPr>
              <p:cNvPr id="23" name="22 CuadroTexto"/>
              <p:cNvSpPr txBox="1"/>
              <p:nvPr/>
            </p:nvSpPr>
            <p:spPr>
              <a:xfrm>
                <a:off x="5748865" y="1586820"/>
                <a:ext cx="99906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/>
                  <a:t>H. </a:t>
                </a:r>
                <a:r>
                  <a:rPr lang="es-ES" sz="1200" i="1" dirty="0" err="1" smtClean="0"/>
                  <a:t>stenolepis</a:t>
                </a:r>
                <a:endParaRPr lang="es-ES" sz="1200" i="1" dirty="0"/>
              </a:p>
            </p:txBody>
          </p:sp>
          <p:sp>
            <p:nvSpPr>
              <p:cNvPr id="24" name="23 CuadroTexto"/>
              <p:cNvSpPr txBox="1"/>
              <p:nvPr/>
            </p:nvSpPr>
            <p:spPr>
              <a:xfrm>
                <a:off x="5731925" y="1781102"/>
                <a:ext cx="11938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/>
                  <a:t>H. </a:t>
                </a:r>
                <a:r>
                  <a:rPr lang="es-ES" sz="1200" i="1" dirty="0" err="1" smtClean="0"/>
                  <a:t>hippoglossus</a:t>
                </a:r>
                <a:endParaRPr lang="es-ES" sz="1200" i="1" dirty="0"/>
              </a:p>
            </p:txBody>
          </p:sp>
          <p:sp>
            <p:nvSpPr>
              <p:cNvPr id="25" name="24 CuadroTexto"/>
              <p:cNvSpPr txBox="1"/>
              <p:nvPr/>
            </p:nvSpPr>
            <p:spPr>
              <a:xfrm>
                <a:off x="5757320" y="1990123"/>
                <a:ext cx="99061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/>
                  <a:t>P. </a:t>
                </a:r>
                <a:r>
                  <a:rPr lang="es-ES" sz="1200" i="1" dirty="0" err="1" smtClean="0"/>
                  <a:t>olivaceous</a:t>
                </a:r>
                <a:endParaRPr lang="es-ES" sz="1200" i="1" dirty="0"/>
              </a:p>
            </p:txBody>
          </p:sp>
          <p:sp>
            <p:nvSpPr>
              <p:cNvPr id="26" name="25 CuadroTexto"/>
              <p:cNvSpPr txBox="1"/>
              <p:nvPr/>
            </p:nvSpPr>
            <p:spPr>
              <a:xfrm>
                <a:off x="5621842" y="2175938"/>
                <a:ext cx="11938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/>
                  <a:t>S. </a:t>
                </a:r>
                <a:r>
                  <a:rPr lang="es-ES" sz="1200" i="1" dirty="0" err="1" smtClean="0"/>
                  <a:t>maximus</a:t>
                </a:r>
                <a:endParaRPr lang="es-ES" sz="1200" i="1" dirty="0"/>
              </a:p>
            </p:txBody>
          </p:sp>
          <p:sp>
            <p:nvSpPr>
              <p:cNvPr id="27" name="26 CuadroTexto"/>
              <p:cNvSpPr txBox="1"/>
              <p:nvPr/>
            </p:nvSpPr>
            <p:spPr>
              <a:xfrm>
                <a:off x="5740374" y="2387607"/>
                <a:ext cx="11938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/>
                  <a:t>S. </a:t>
                </a:r>
                <a:r>
                  <a:rPr lang="es-ES" sz="1200" i="1" dirty="0" err="1" smtClean="0"/>
                  <a:t>senegalensis</a:t>
                </a:r>
                <a:endParaRPr lang="es-ES" sz="1200" i="1" dirty="0"/>
              </a:p>
            </p:txBody>
          </p:sp>
          <p:sp>
            <p:nvSpPr>
              <p:cNvPr id="28" name="27 CuadroTexto"/>
              <p:cNvSpPr txBox="1"/>
              <p:nvPr/>
            </p:nvSpPr>
            <p:spPr>
              <a:xfrm>
                <a:off x="5664165" y="2599276"/>
                <a:ext cx="11938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/>
                  <a:t>C. </a:t>
                </a:r>
                <a:r>
                  <a:rPr lang="es-ES" sz="1200" i="1" dirty="0" err="1" smtClean="0"/>
                  <a:t>semilaevis</a:t>
                </a:r>
                <a:endParaRPr lang="es-ES" sz="1200" i="1" dirty="0"/>
              </a:p>
            </p:txBody>
          </p:sp>
          <p:sp>
            <p:nvSpPr>
              <p:cNvPr id="29" name="28 CuadroTexto"/>
              <p:cNvSpPr txBox="1"/>
              <p:nvPr/>
            </p:nvSpPr>
            <p:spPr>
              <a:xfrm>
                <a:off x="5689593" y="2819402"/>
                <a:ext cx="82127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/>
                  <a:t>D. </a:t>
                </a:r>
                <a:r>
                  <a:rPr lang="es-ES" sz="1200" i="1" dirty="0" err="1" smtClean="0"/>
                  <a:t>rerio</a:t>
                </a:r>
                <a:endParaRPr lang="es-ES" sz="1200" i="1" dirty="0"/>
              </a:p>
            </p:txBody>
          </p:sp>
        </p:grpSp>
        <p:sp>
          <p:nvSpPr>
            <p:cNvPr id="20" name="19 CuadroTexto"/>
            <p:cNvSpPr txBox="1"/>
            <p:nvPr/>
          </p:nvSpPr>
          <p:spPr>
            <a:xfrm>
              <a:off x="4949678" y="3081132"/>
              <a:ext cx="37768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800" dirty="0" smtClean="0"/>
                <a:t>0.07</a:t>
              </a:r>
              <a:endParaRPr lang="es-ES" sz="800" dirty="0"/>
            </a:p>
          </p:txBody>
        </p:sp>
        <p:cxnSp>
          <p:nvCxnSpPr>
            <p:cNvPr id="21" name="20 Conector recto"/>
            <p:cNvCxnSpPr/>
            <p:nvPr/>
          </p:nvCxnSpPr>
          <p:spPr>
            <a:xfrm>
              <a:off x="4899991" y="3071199"/>
              <a:ext cx="4472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35</Words>
  <Application>Microsoft Office PowerPoint</Application>
  <PresentationFormat>Personalizado</PresentationFormat>
  <Paragraphs>25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OUZA FERNANDEZ Ma CARMEN</dc:creator>
  <cp:lastModifiedBy>USUARIO</cp:lastModifiedBy>
  <cp:revision>14</cp:revision>
  <dcterms:created xsi:type="dcterms:W3CDTF">2021-11-22T10:45:57Z</dcterms:created>
  <dcterms:modified xsi:type="dcterms:W3CDTF">2022-02-28T10:37:47Z</dcterms:modified>
</cp:coreProperties>
</file>